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7" r:id="rId2"/>
    <p:sldId id="288" r:id="rId3"/>
    <p:sldId id="256" r:id="rId4"/>
    <p:sldId id="289" r:id="rId5"/>
    <p:sldId id="257" r:id="rId6"/>
    <p:sldId id="290" r:id="rId7"/>
    <p:sldId id="258" r:id="rId8"/>
    <p:sldId id="291" r:id="rId9"/>
    <p:sldId id="259" r:id="rId10"/>
    <p:sldId id="292" r:id="rId11"/>
    <p:sldId id="260" r:id="rId12"/>
    <p:sldId id="293" r:id="rId13"/>
    <p:sldId id="261" r:id="rId14"/>
    <p:sldId id="294" r:id="rId15"/>
    <p:sldId id="262" r:id="rId16"/>
    <p:sldId id="295" r:id="rId17"/>
    <p:sldId id="263" r:id="rId18"/>
    <p:sldId id="296" r:id="rId19"/>
    <p:sldId id="264" r:id="rId20"/>
    <p:sldId id="297" r:id="rId21"/>
    <p:sldId id="265" r:id="rId22"/>
    <p:sldId id="298" r:id="rId23"/>
    <p:sldId id="266" r:id="rId24"/>
    <p:sldId id="299" r:id="rId25"/>
    <p:sldId id="267" r:id="rId26"/>
    <p:sldId id="300" r:id="rId27"/>
    <p:sldId id="268" r:id="rId28"/>
    <p:sldId id="301" r:id="rId29"/>
    <p:sldId id="269" r:id="rId30"/>
    <p:sldId id="302" r:id="rId31"/>
    <p:sldId id="270" r:id="rId32"/>
    <p:sldId id="303" r:id="rId33"/>
    <p:sldId id="271" r:id="rId34"/>
    <p:sldId id="304" r:id="rId35"/>
    <p:sldId id="272" r:id="rId36"/>
    <p:sldId id="305" r:id="rId37"/>
    <p:sldId id="273" r:id="rId38"/>
    <p:sldId id="306" r:id="rId39"/>
    <p:sldId id="274" r:id="rId40"/>
    <p:sldId id="307" r:id="rId41"/>
    <p:sldId id="275" r:id="rId42"/>
    <p:sldId id="308" r:id="rId43"/>
    <p:sldId id="276" r:id="rId44"/>
    <p:sldId id="309" r:id="rId45"/>
    <p:sldId id="277" r:id="rId46"/>
    <p:sldId id="316" r:id="rId47"/>
    <p:sldId id="278" r:id="rId48"/>
    <p:sldId id="310" r:id="rId49"/>
    <p:sldId id="279" r:id="rId50"/>
    <p:sldId id="311" r:id="rId51"/>
    <p:sldId id="280" r:id="rId52"/>
    <p:sldId id="312" r:id="rId53"/>
    <p:sldId id="281" r:id="rId54"/>
    <p:sldId id="317" r:id="rId55"/>
    <p:sldId id="282" r:id="rId56"/>
    <p:sldId id="313" r:id="rId57"/>
    <p:sldId id="283" r:id="rId58"/>
    <p:sldId id="314" r:id="rId59"/>
    <p:sldId id="284" r:id="rId60"/>
    <p:sldId id="318" r:id="rId61"/>
    <p:sldId id="285" r:id="rId62"/>
    <p:sldId id="315" r:id="rId63"/>
    <p:sldId id="286" r:id="rId64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34604" autoAdjust="0"/>
    <p:restoredTop sz="94697" autoAdjust="0"/>
  </p:normalViewPr>
  <p:slideViewPr>
    <p:cSldViewPr>
      <p:cViewPr varScale="1">
        <p:scale>
          <a:sx n="49" d="100"/>
          <a:sy n="49" d="100"/>
        </p:scale>
        <p:origin x="-2220" y="-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7404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slide" Target="slides/slide62.xml"/><Relationship Id="rId68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61" Type="http://schemas.openxmlformats.org/officeDocument/2006/relationships/slide" Target="slides/slide60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theme" Target="theme/theme1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80680-770F-4B7A-9FED-F5EFDC944F84}" type="datetimeFigureOut">
              <a:rPr kumimoji="1" lang="ja-JP" altLang="en-US" smtClean="0"/>
              <a:t>2012/9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115F-4E58-47D6-8347-E13FDCEEA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7436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80680-770F-4B7A-9FED-F5EFDC944F84}" type="datetimeFigureOut">
              <a:rPr kumimoji="1" lang="ja-JP" altLang="en-US" smtClean="0"/>
              <a:t>2012/9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115F-4E58-47D6-8347-E13FDCEEA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200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80680-770F-4B7A-9FED-F5EFDC944F84}" type="datetimeFigureOut">
              <a:rPr kumimoji="1" lang="ja-JP" altLang="en-US" smtClean="0"/>
              <a:t>2012/9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115F-4E58-47D6-8347-E13FDCEEA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6245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80680-770F-4B7A-9FED-F5EFDC944F84}" type="datetimeFigureOut">
              <a:rPr kumimoji="1" lang="ja-JP" altLang="en-US" smtClean="0"/>
              <a:t>2012/9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115F-4E58-47D6-8347-E13FDCEEA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1234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80680-770F-4B7A-9FED-F5EFDC944F84}" type="datetimeFigureOut">
              <a:rPr kumimoji="1" lang="ja-JP" altLang="en-US" smtClean="0"/>
              <a:t>2012/9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115F-4E58-47D6-8347-E13FDCEEA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1062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80680-770F-4B7A-9FED-F5EFDC944F84}" type="datetimeFigureOut">
              <a:rPr kumimoji="1" lang="ja-JP" altLang="en-US" smtClean="0"/>
              <a:t>2012/9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115F-4E58-47D6-8347-E13FDCEEA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3183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80680-770F-4B7A-9FED-F5EFDC944F84}" type="datetimeFigureOut">
              <a:rPr kumimoji="1" lang="ja-JP" altLang="en-US" smtClean="0"/>
              <a:t>2012/9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115F-4E58-47D6-8347-E13FDCEEA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8988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80680-770F-4B7A-9FED-F5EFDC944F84}" type="datetimeFigureOut">
              <a:rPr kumimoji="1" lang="ja-JP" altLang="en-US" smtClean="0"/>
              <a:t>2012/9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115F-4E58-47D6-8347-E13FDCEEA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8715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80680-770F-4B7A-9FED-F5EFDC944F84}" type="datetimeFigureOut">
              <a:rPr kumimoji="1" lang="ja-JP" altLang="en-US" smtClean="0"/>
              <a:t>2012/9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115F-4E58-47D6-8347-E13FDCEEA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0196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80680-770F-4B7A-9FED-F5EFDC944F84}" type="datetimeFigureOut">
              <a:rPr kumimoji="1" lang="ja-JP" altLang="en-US" smtClean="0"/>
              <a:t>2012/9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115F-4E58-47D6-8347-E13FDCEEA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6932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80680-770F-4B7A-9FED-F5EFDC944F84}" type="datetimeFigureOut">
              <a:rPr kumimoji="1" lang="ja-JP" altLang="en-US" smtClean="0"/>
              <a:t>2012/9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E115F-4E58-47D6-8347-E13FDCEEA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0317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80680-770F-4B7A-9FED-F5EFDC944F84}" type="datetimeFigureOut">
              <a:rPr kumimoji="1" lang="ja-JP" altLang="en-US" smtClean="0"/>
              <a:t>2012/9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E115F-4E58-47D6-8347-E13FDCEEA9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7593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2"/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182"/>
          <a:stretch/>
        </p:blipFill>
        <p:spPr>
          <a:xfrm>
            <a:off x="-3369" y="1691680"/>
            <a:ext cx="6864739" cy="6636172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テキスト ボックス 5"/>
          <p:cNvSpPr txBox="1"/>
          <p:nvPr/>
        </p:nvSpPr>
        <p:spPr>
          <a:xfrm>
            <a:off x="584684" y="622906"/>
            <a:ext cx="568863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4000" dirty="0" smtClean="0"/>
              <a:t>フリック入力一覧表</a:t>
            </a:r>
            <a:endParaRPr kumimoji="1" lang="ja-JP" altLang="en-US" sz="4000" dirty="0"/>
          </a:p>
        </p:txBody>
      </p:sp>
    </p:spTree>
    <p:extLst>
      <p:ext uri="{BB962C8B-B14F-4D97-AF65-F5344CB8AC3E}">
        <p14:creationId xmlns:p14="http://schemas.microsoft.com/office/powerpoint/2010/main" val="32033417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9821076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3852014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8362390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1616701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9633755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408282687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15500"/>
    </mc:Choice>
    <mc:Fallback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177951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60000"/>
    </mc:Choice>
    <mc:Fallback>
      <p:transition spd="slow" advTm="60000"/>
    </mc:Fallback>
  </mc:AlternateContent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6308413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4814155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5044528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9873968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en-US" altLang="ja-JP" sz="5500" dirty="0" smtClean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0512755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4529992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52988642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7363496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1567103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8321767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5591314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262039551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6760642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en-US" altLang="ja-JP" sz="5500" dirty="0" smtClean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en-US" altLang="ja-JP" sz="5500" dirty="0" smtClean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60000"/>
    </mc:Choice>
    <mc:Fallback>
      <p:transition spd="slow" advTm="60000"/>
    </mc:Fallback>
  </mc:AlternateContent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5266810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en-US" altLang="ja-JP" sz="5500" dirty="0" smtClean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5396619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8811799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5396619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216269557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5495193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5396619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0934615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5396619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3539844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8674150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0580883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5396619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3552712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5396619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37944414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3747819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5500" dirty="0" smtClean="0"/>
                        <a:t>に</a:t>
                      </a:r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5396619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5553871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en-US" altLang="ja-JP" sz="5500" dirty="0" smtClean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5396619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9106743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5396619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37944414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2253781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5396619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27019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ち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2452151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3482273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て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め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十字形 3"/>
          <p:cNvSpPr/>
          <p:nvPr/>
        </p:nvSpPr>
        <p:spPr>
          <a:xfrm>
            <a:off x="2132856" y="3275856"/>
            <a:ext cx="2592288" cy="2592288"/>
          </a:xfrm>
          <a:prstGeom prst="plus">
            <a:avLst>
              <a:gd name="adj" fmla="val 32668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 w="18415" cmpd="sng">
                <a:solidFill>
                  <a:srgbClr val="FFFFFF"/>
                </a:solidFill>
                <a:prstDash val="solid"/>
              </a:ln>
              <a:solidFill>
                <a:srgbClr val="FFFFFF"/>
              </a:solidFill>
              <a:effectLst>
                <a:outerShdw blurRad="63500" dir="3600000" algn="tl" rotWithShape="0">
                  <a:srgbClr val="000000">
                    <a:alpha val="70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14349633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Tm="25000"/>
    </mc:Choice>
    <mc:Fallback>
      <p:transition spd="slow" advTm="25000"/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2809058"/>
              </p:ext>
            </p:extLst>
          </p:nvPr>
        </p:nvGraphicFramePr>
        <p:xfrm>
          <a:off x="0" y="-6"/>
          <a:ext cx="6858000" cy="91440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71600"/>
                <a:gridCol w="1371600"/>
                <a:gridCol w="1371600"/>
                <a:gridCol w="1371600"/>
                <a:gridCol w="1371600"/>
              </a:tblGrid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ら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す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ま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の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せ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そ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ほ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ひ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く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ん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な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か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ね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れ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つ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に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さ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を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ぬ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や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よ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ふ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け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へ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た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き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み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と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お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16001"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も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ゆ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は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む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5500" dirty="0" smtClean="0"/>
                        <a:t>し</a:t>
                      </a:r>
                      <a:endParaRPr kumimoji="1" lang="ja-JP" altLang="en-US" sz="5500" dirty="0"/>
                    </a:p>
                  </a:txBody>
                  <a:tcPr marT="42203" marB="42203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4632919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5000"/>
    </mc:Choice>
    <mc:Fallback>
      <p:transition spd="slow" advClick="0" advTm="15000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1398</Words>
  <Application>Microsoft Office PowerPoint</Application>
  <PresentationFormat>画面に合わせる (4:3)</PresentationFormat>
  <Paragraphs>1396</Paragraphs>
  <Slides>63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63</vt:i4>
      </vt:variant>
    </vt:vector>
  </HeadingPairs>
  <TitlesOfParts>
    <vt:vector size="64" baseType="lpstr"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内剛史</dc:creator>
  <cp:lastModifiedBy>森内剛史</cp:lastModifiedBy>
  <cp:revision>13</cp:revision>
  <dcterms:created xsi:type="dcterms:W3CDTF">2012-09-17T11:42:28Z</dcterms:created>
  <dcterms:modified xsi:type="dcterms:W3CDTF">2012-09-17T14:18:50Z</dcterms:modified>
</cp:coreProperties>
</file>